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30240288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4" d="100"/>
          <a:sy n="34" d="100"/>
        </p:scale>
        <p:origin x="162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68022" y="3534924"/>
            <a:ext cx="25704245" cy="7519835"/>
          </a:xfrm>
        </p:spPr>
        <p:txBody>
          <a:bodyPr anchor="b"/>
          <a:lstStyle>
            <a:lvl1pPr algn="ctr">
              <a:defRPr sz="188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0036" y="11344752"/>
            <a:ext cx="22680216" cy="521488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39951" indent="0" algn="ctr">
              <a:buNone/>
              <a:defRPr sz="6299"/>
            </a:lvl2pPr>
            <a:lvl3pPr marL="2879903" indent="0" algn="ctr">
              <a:buNone/>
              <a:defRPr sz="5669"/>
            </a:lvl3pPr>
            <a:lvl4pPr marL="4319854" indent="0" algn="ctr">
              <a:buNone/>
              <a:defRPr sz="5039"/>
            </a:lvl4pPr>
            <a:lvl5pPr marL="5759806" indent="0" algn="ctr">
              <a:buNone/>
              <a:defRPr sz="5039"/>
            </a:lvl5pPr>
            <a:lvl6pPr marL="7199757" indent="0" algn="ctr">
              <a:buNone/>
              <a:defRPr sz="5039"/>
            </a:lvl6pPr>
            <a:lvl7pPr marL="8639708" indent="0" algn="ctr">
              <a:buNone/>
              <a:defRPr sz="5039"/>
            </a:lvl7pPr>
            <a:lvl8pPr marL="10079660" indent="0" algn="ctr">
              <a:buNone/>
              <a:defRPr sz="5039"/>
            </a:lvl8pPr>
            <a:lvl9pPr marL="11519611" indent="0" algn="ctr">
              <a:buNone/>
              <a:defRPr sz="503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6926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9438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40708" y="1149975"/>
            <a:ext cx="6520562" cy="183045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79021" y="1149975"/>
            <a:ext cx="19183683" cy="183045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6276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806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3272" y="5384888"/>
            <a:ext cx="26082248" cy="8984801"/>
          </a:xfrm>
        </p:spPr>
        <p:txBody>
          <a:bodyPr anchor="b"/>
          <a:lstStyle>
            <a:lvl1pPr>
              <a:defRPr sz="188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3272" y="14454688"/>
            <a:ext cx="26082248" cy="4724895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39951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79903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19854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4pPr>
            <a:lvl5pPr marL="5759806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5pPr>
            <a:lvl6pPr marL="7199757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6pPr>
            <a:lvl7pPr marL="8639708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7pPr>
            <a:lvl8pPr marL="10079660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8pPr>
            <a:lvl9pPr marL="1151961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311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79020" y="5749874"/>
            <a:ext cx="12852122" cy="1370470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09146" y="5749874"/>
            <a:ext cx="12852122" cy="1370470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468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2959" y="1149979"/>
            <a:ext cx="26082248" cy="417491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2962" y="5294885"/>
            <a:ext cx="12793057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2962" y="7889827"/>
            <a:ext cx="12793057" cy="1160474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09148" y="5294885"/>
            <a:ext cx="12856061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09148" y="7889827"/>
            <a:ext cx="12856061" cy="1160474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899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719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663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2959" y="1439968"/>
            <a:ext cx="9753280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56061" y="3109937"/>
            <a:ext cx="15309146" cy="15349662"/>
          </a:xfrm>
        </p:spPr>
        <p:txBody>
          <a:bodyPr/>
          <a:lstStyle>
            <a:lvl1pPr>
              <a:defRPr sz="10078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2959" y="6479857"/>
            <a:ext cx="9753280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6339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2959" y="1439968"/>
            <a:ext cx="9753280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56061" y="3109937"/>
            <a:ext cx="15309146" cy="15349662"/>
          </a:xfrm>
        </p:spPr>
        <p:txBody>
          <a:bodyPr anchor="t"/>
          <a:lstStyle>
            <a:lvl1pPr marL="0" indent="0">
              <a:buNone/>
              <a:defRPr sz="10078"/>
            </a:lvl1pPr>
            <a:lvl2pPr marL="1439951" indent="0">
              <a:buNone/>
              <a:defRPr sz="8819"/>
            </a:lvl2pPr>
            <a:lvl3pPr marL="2879903" indent="0">
              <a:buNone/>
              <a:defRPr sz="7559"/>
            </a:lvl3pPr>
            <a:lvl4pPr marL="4319854" indent="0">
              <a:buNone/>
              <a:defRPr sz="6299"/>
            </a:lvl4pPr>
            <a:lvl5pPr marL="5759806" indent="0">
              <a:buNone/>
              <a:defRPr sz="6299"/>
            </a:lvl5pPr>
            <a:lvl6pPr marL="7199757" indent="0">
              <a:buNone/>
              <a:defRPr sz="6299"/>
            </a:lvl6pPr>
            <a:lvl7pPr marL="8639708" indent="0">
              <a:buNone/>
              <a:defRPr sz="6299"/>
            </a:lvl7pPr>
            <a:lvl8pPr marL="10079660" indent="0">
              <a:buNone/>
              <a:defRPr sz="6299"/>
            </a:lvl8pPr>
            <a:lvl9pPr marL="11519611" indent="0">
              <a:buNone/>
              <a:defRPr sz="629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2959" y="6479857"/>
            <a:ext cx="9753280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2429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79020" y="1149979"/>
            <a:ext cx="26082248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79020" y="5749874"/>
            <a:ext cx="26082248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79020" y="20019564"/>
            <a:ext cx="6804065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938B89-91D8-4180-B3FE-32D892D63740}" type="datetimeFigureOut">
              <a:rPr lang="zh-CN" altLang="en-US" smtClean="0"/>
              <a:t>2025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17096" y="20019564"/>
            <a:ext cx="10206097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57203" y="20019564"/>
            <a:ext cx="6804065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5BD263D-AA0A-4EF8-BF5F-3F30CEF76B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2774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2879903" rtl="0" eaLnBrk="1" latinLnBrk="0" hangingPunct="1">
        <a:lnSpc>
          <a:spcPct val="90000"/>
        </a:lnSpc>
        <a:spcBef>
          <a:spcPct val="0"/>
        </a:spcBef>
        <a:buNone/>
        <a:defRPr sz="13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976" indent="-719976" algn="l" defTabSz="2879903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5992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599879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39830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79781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19733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59684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799636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3958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5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19854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59806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199757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39708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7966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1961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8" name="组合 207">
            <a:extLst>
              <a:ext uri="{FF2B5EF4-FFF2-40B4-BE49-F238E27FC236}">
                <a16:creationId xmlns:a16="http://schemas.microsoft.com/office/drawing/2014/main" id="{B599EE38-8B67-1693-9C9A-0772A267F3CF}"/>
              </a:ext>
            </a:extLst>
          </p:cNvPr>
          <p:cNvGrpSpPr/>
          <p:nvPr/>
        </p:nvGrpSpPr>
        <p:grpSpPr>
          <a:xfrm>
            <a:off x="0" y="1596460"/>
            <a:ext cx="30041418" cy="17258112"/>
            <a:chOff x="-8397685" y="-6269347"/>
            <a:chExt cx="30041418" cy="17258112"/>
          </a:xfrm>
        </p:grpSpPr>
        <p:pic>
          <p:nvPicPr>
            <p:cNvPr id="209" name="图片 208" descr="图片包含 背景图案&#10;&#10;描述已自动生成">
              <a:extLst>
                <a:ext uri="{FF2B5EF4-FFF2-40B4-BE49-F238E27FC236}">
                  <a16:creationId xmlns:a16="http://schemas.microsoft.com/office/drawing/2014/main" id="{AAA06F24-D5C6-9C5C-6186-E94EF17BF9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036788" y="-5196699"/>
              <a:ext cx="4718304" cy="3560064"/>
            </a:xfrm>
            <a:prstGeom prst="rect">
              <a:avLst/>
            </a:prstGeom>
          </p:spPr>
        </p:pic>
        <p:pic>
          <p:nvPicPr>
            <p:cNvPr id="210" name="图片 209" descr="背景图案&#10;&#10;描述已自动生成">
              <a:extLst>
                <a:ext uri="{FF2B5EF4-FFF2-40B4-BE49-F238E27FC236}">
                  <a16:creationId xmlns:a16="http://schemas.microsoft.com/office/drawing/2014/main" id="{BE4D5308-7B44-2939-F11A-97348A1B908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036788" y="-1259809"/>
              <a:ext cx="4718304" cy="3560064"/>
            </a:xfrm>
            <a:prstGeom prst="rect">
              <a:avLst/>
            </a:prstGeom>
          </p:spPr>
        </p:pic>
        <p:pic>
          <p:nvPicPr>
            <p:cNvPr id="211" name="图片 210" descr="图片包含 地图&#10;&#10;描述已自动生成">
              <a:extLst>
                <a:ext uri="{FF2B5EF4-FFF2-40B4-BE49-F238E27FC236}">
                  <a16:creationId xmlns:a16="http://schemas.microsoft.com/office/drawing/2014/main" id="{EB62D194-FFAD-A1EA-EA26-08FB201F101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3932" y="-5196699"/>
              <a:ext cx="4718304" cy="3560064"/>
            </a:xfrm>
            <a:prstGeom prst="rect">
              <a:avLst/>
            </a:prstGeom>
          </p:spPr>
        </p:pic>
        <p:pic>
          <p:nvPicPr>
            <p:cNvPr id="212" name="图片 211" descr="地图&#10;&#10;描述已自动生成">
              <a:extLst>
                <a:ext uri="{FF2B5EF4-FFF2-40B4-BE49-F238E27FC236}">
                  <a16:creationId xmlns:a16="http://schemas.microsoft.com/office/drawing/2014/main" id="{62168798-63D6-7EF1-7C64-1FAD1BDB34B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3932" y="-1259809"/>
              <a:ext cx="4718304" cy="3560064"/>
            </a:xfrm>
            <a:prstGeom prst="rect">
              <a:avLst/>
            </a:prstGeom>
          </p:spPr>
        </p:pic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3B305485-130B-F383-E108-8B317B078151}"/>
                </a:ext>
              </a:extLst>
            </p:cNvPr>
            <p:cNvSpPr txBox="1"/>
            <p:nvPr/>
          </p:nvSpPr>
          <p:spPr>
            <a:xfrm>
              <a:off x="-5903741" y="-5904585"/>
              <a:ext cx="293076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CITE2-RNA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B7B37BC1-FB6E-ED7C-51C7-BB0184021D5A}"/>
                </a:ext>
              </a:extLst>
            </p:cNvPr>
            <p:cNvSpPr txBox="1"/>
            <p:nvPr/>
          </p:nvSpPr>
          <p:spPr>
            <a:xfrm>
              <a:off x="-143021" y="-5904585"/>
              <a:ext cx="293076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CITE2-ADT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81DF4DD1-BACD-47FC-CB59-48EB6E79E1CB}"/>
                </a:ext>
              </a:extLst>
            </p:cNvPr>
            <p:cNvSpPr txBox="1"/>
            <p:nvPr/>
          </p:nvSpPr>
          <p:spPr>
            <a:xfrm>
              <a:off x="5647946" y="-5904585"/>
              <a:ext cx="325385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CITE2-WNN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文本框 215">
              <a:extLst>
                <a:ext uri="{FF2B5EF4-FFF2-40B4-BE49-F238E27FC236}">
                  <a16:creationId xmlns:a16="http://schemas.microsoft.com/office/drawing/2014/main" id="{713F9A74-B378-F85F-AEA9-214B47F5CF37}"/>
                </a:ext>
              </a:extLst>
            </p:cNvPr>
            <p:cNvSpPr txBox="1"/>
            <p:nvPr/>
          </p:nvSpPr>
          <p:spPr>
            <a:xfrm>
              <a:off x="-6872831" y="2377391"/>
              <a:ext cx="5025212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VP-RNA-Raw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7" name="图片 216" descr="背景图案&#10;&#10;描述已自动生成">
              <a:extLst>
                <a:ext uri="{FF2B5EF4-FFF2-40B4-BE49-F238E27FC236}">
                  <a16:creationId xmlns:a16="http://schemas.microsoft.com/office/drawing/2014/main" id="{09B0CF3F-5603-AE83-F182-8B616A7D57F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07438" y="3635607"/>
              <a:ext cx="4718304" cy="3560064"/>
            </a:xfrm>
            <a:prstGeom prst="rect">
              <a:avLst/>
            </a:prstGeom>
          </p:spPr>
        </p:pic>
        <p:pic>
          <p:nvPicPr>
            <p:cNvPr id="218" name="图片 217" descr="图片包含 背景图案&#10;&#10;描述已自动生成">
              <a:extLst>
                <a:ext uri="{FF2B5EF4-FFF2-40B4-BE49-F238E27FC236}">
                  <a16:creationId xmlns:a16="http://schemas.microsoft.com/office/drawing/2014/main" id="{3537E123-C617-3DD4-1C39-907EF8D277C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07438" y="7428701"/>
              <a:ext cx="4718304" cy="3560064"/>
            </a:xfrm>
            <a:prstGeom prst="rect">
              <a:avLst/>
            </a:prstGeom>
          </p:spPr>
        </p:pic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1BFB4714-4527-7E1A-B0AD-0003F6EC695A}"/>
                </a:ext>
              </a:extLst>
            </p:cNvPr>
            <p:cNvSpPr txBox="1"/>
            <p:nvPr/>
          </p:nvSpPr>
          <p:spPr>
            <a:xfrm>
              <a:off x="7731118" y="2927721"/>
              <a:ext cx="324193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CYTOF-Raw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0" name="图片 219" descr="图表&#10;&#10;中度可信度描述已自动生成">
              <a:extLst>
                <a:ext uri="{FF2B5EF4-FFF2-40B4-BE49-F238E27FC236}">
                  <a16:creationId xmlns:a16="http://schemas.microsoft.com/office/drawing/2014/main" id="{D49CF04C-008E-F5B6-7809-E968F53FB69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805310" y="3572957"/>
              <a:ext cx="4718304" cy="3560064"/>
            </a:xfrm>
            <a:prstGeom prst="rect">
              <a:avLst/>
            </a:prstGeom>
          </p:spPr>
        </p:pic>
        <p:pic>
          <p:nvPicPr>
            <p:cNvPr id="221" name="图片 220" descr="背景图案&#10;&#10;描述已自动生成">
              <a:extLst>
                <a:ext uri="{FF2B5EF4-FFF2-40B4-BE49-F238E27FC236}">
                  <a16:creationId xmlns:a16="http://schemas.microsoft.com/office/drawing/2014/main" id="{5269CC8A-8269-E277-EEAA-34085C3473E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805310" y="7426918"/>
              <a:ext cx="4718304" cy="3560064"/>
            </a:xfrm>
            <a:prstGeom prst="rect">
              <a:avLst/>
            </a:prstGeom>
          </p:spPr>
        </p:pic>
        <p:pic>
          <p:nvPicPr>
            <p:cNvPr id="222" name="图片 221" descr="图片包含 背景图案&#10;&#10;描述已自动生成">
              <a:extLst>
                <a:ext uri="{FF2B5EF4-FFF2-40B4-BE49-F238E27FC236}">
                  <a16:creationId xmlns:a16="http://schemas.microsoft.com/office/drawing/2014/main" id="{65930BA9-13F4-76A8-B9F8-C1043EBDEB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997" t="34355" r="1009" b="32112"/>
            <a:stretch/>
          </p:blipFill>
          <p:spPr>
            <a:xfrm>
              <a:off x="15471419" y="-1259809"/>
              <a:ext cx="2256218" cy="3842110"/>
            </a:xfrm>
            <a:prstGeom prst="rect">
              <a:avLst/>
            </a:prstGeom>
          </p:spPr>
        </p:pic>
        <p:pic>
          <p:nvPicPr>
            <p:cNvPr id="223" name="图片 222" descr="图片包含 背景图案&#10;&#10;描述已自动生成">
              <a:extLst>
                <a:ext uri="{FF2B5EF4-FFF2-40B4-BE49-F238E27FC236}">
                  <a16:creationId xmlns:a16="http://schemas.microsoft.com/office/drawing/2014/main" id="{E2AD646C-F246-D514-B081-56543C346C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171" t="37298" b="37302"/>
            <a:stretch/>
          </p:blipFill>
          <p:spPr>
            <a:xfrm>
              <a:off x="3674136" y="4101601"/>
              <a:ext cx="2736880" cy="2637925"/>
            </a:xfrm>
            <a:prstGeom prst="rect">
              <a:avLst/>
            </a:prstGeom>
          </p:spPr>
        </p:pic>
        <p:pic>
          <p:nvPicPr>
            <p:cNvPr id="224" name="图片 223" descr="背景图案&#10;&#10;描述已自动生成">
              <a:extLst>
                <a:ext uri="{FF2B5EF4-FFF2-40B4-BE49-F238E27FC236}">
                  <a16:creationId xmlns:a16="http://schemas.microsoft.com/office/drawing/2014/main" id="{1A7D6D33-0331-2E35-F89D-F1A48FB807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779" t="36623" b="36836"/>
            <a:stretch/>
          </p:blipFill>
          <p:spPr>
            <a:xfrm>
              <a:off x="3674136" y="7757072"/>
              <a:ext cx="2520152" cy="2877111"/>
            </a:xfrm>
            <a:prstGeom prst="rect">
              <a:avLst/>
            </a:prstGeom>
          </p:spPr>
        </p:pic>
        <p:pic>
          <p:nvPicPr>
            <p:cNvPr id="225" name="图片 224" descr="图片包含 散点图&#10;&#10;描述已自动生成">
              <a:extLst>
                <a:ext uri="{FF2B5EF4-FFF2-40B4-BE49-F238E27FC236}">
                  <a16:creationId xmlns:a16="http://schemas.microsoft.com/office/drawing/2014/main" id="{F2EB86F4-A2C6-BCA5-3CA1-C37959D405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876" t="32526" b="31515"/>
            <a:stretch/>
          </p:blipFill>
          <p:spPr>
            <a:xfrm>
              <a:off x="17135630" y="3826306"/>
              <a:ext cx="4508103" cy="3178666"/>
            </a:xfrm>
            <a:prstGeom prst="rect">
              <a:avLst/>
            </a:prstGeom>
          </p:spPr>
        </p:pic>
        <p:pic>
          <p:nvPicPr>
            <p:cNvPr id="226" name="图片 225" descr="散点图&#10;&#10;描述已自动生成">
              <a:extLst>
                <a:ext uri="{FF2B5EF4-FFF2-40B4-BE49-F238E27FC236}">
                  <a16:creationId xmlns:a16="http://schemas.microsoft.com/office/drawing/2014/main" id="{A9DB7294-AEA0-5973-AB3E-F311BF1BE0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02" t="26212" b="23762"/>
            <a:stretch/>
          </p:blipFill>
          <p:spPr>
            <a:xfrm>
              <a:off x="17135630" y="7612378"/>
              <a:ext cx="3484556" cy="3213389"/>
            </a:xfrm>
            <a:prstGeom prst="rect">
              <a:avLst/>
            </a:prstGeom>
          </p:spPr>
        </p:pic>
        <p:pic>
          <p:nvPicPr>
            <p:cNvPr id="227" name="图片 226" descr="卡通人物&#10;&#10;低可信度描述已自动生成">
              <a:extLst>
                <a:ext uri="{FF2B5EF4-FFF2-40B4-BE49-F238E27FC236}">
                  <a16:creationId xmlns:a16="http://schemas.microsoft.com/office/drawing/2014/main" id="{E9D00F51-FE47-E203-E470-D141BD6BC17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755770" y="-5196699"/>
              <a:ext cx="4718304" cy="3560064"/>
            </a:xfrm>
            <a:prstGeom prst="rect">
              <a:avLst/>
            </a:prstGeom>
          </p:spPr>
        </p:pic>
        <p:pic>
          <p:nvPicPr>
            <p:cNvPr id="228" name="图片 227" descr="背景图案&#10;&#10;描述已自动生成">
              <a:extLst>
                <a:ext uri="{FF2B5EF4-FFF2-40B4-BE49-F238E27FC236}">
                  <a16:creationId xmlns:a16="http://schemas.microsoft.com/office/drawing/2014/main" id="{7194CFAB-2985-646C-3B8F-0682A15663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755770" y="-1259809"/>
              <a:ext cx="4718304" cy="3560064"/>
            </a:xfrm>
            <a:prstGeom prst="rect">
              <a:avLst/>
            </a:prstGeom>
          </p:spPr>
        </p:pic>
        <p:pic>
          <p:nvPicPr>
            <p:cNvPr id="229" name="图片 228" descr="图片包含 背景图案&#10;&#10;描述已自动生成">
              <a:extLst>
                <a:ext uri="{FF2B5EF4-FFF2-40B4-BE49-F238E27FC236}">
                  <a16:creationId xmlns:a16="http://schemas.microsoft.com/office/drawing/2014/main" id="{421FDD3E-B528-FD84-F2E1-D8A83C1041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21" t="38855" r="1323" b="37743"/>
            <a:stretch/>
          </p:blipFill>
          <p:spPr>
            <a:xfrm>
              <a:off x="15471419" y="-4760995"/>
              <a:ext cx="1278751" cy="2688656"/>
            </a:xfrm>
            <a:prstGeom prst="rect">
              <a:avLst/>
            </a:prstGeom>
          </p:spPr>
        </p:pic>
        <p:pic>
          <p:nvPicPr>
            <p:cNvPr id="230" name="图片 229" descr="背景图案&#10;&#10;描述已自动生成">
              <a:extLst>
                <a:ext uri="{FF2B5EF4-FFF2-40B4-BE49-F238E27FC236}">
                  <a16:creationId xmlns:a16="http://schemas.microsoft.com/office/drawing/2014/main" id="{DAD6B1C7-5319-54B7-6C6B-8506E37E19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92000" y="3635607"/>
              <a:ext cx="4718304" cy="3560064"/>
            </a:xfrm>
            <a:prstGeom prst="rect">
              <a:avLst/>
            </a:prstGeom>
          </p:spPr>
        </p:pic>
        <p:pic>
          <p:nvPicPr>
            <p:cNvPr id="231" name="图片 230" descr="图片包含 背景图案&#10;&#10;描述已自动生成">
              <a:extLst>
                <a:ext uri="{FF2B5EF4-FFF2-40B4-BE49-F238E27FC236}">
                  <a16:creationId xmlns:a16="http://schemas.microsoft.com/office/drawing/2014/main" id="{D1CD37BE-979B-2CE9-10D8-61EB170222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92000" y="7415595"/>
              <a:ext cx="4718304" cy="3560064"/>
            </a:xfrm>
            <a:prstGeom prst="rect">
              <a:avLst/>
            </a:prstGeom>
          </p:spPr>
        </p:pic>
        <p:pic>
          <p:nvPicPr>
            <p:cNvPr id="232" name="图片 231" descr="图片包含 背景图案&#10;&#10;描述已自动生成">
              <a:extLst>
                <a:ext uri="{FF2B5EF4-FFF2-40B4-BE49-F238E27FC236}">
                  <a16:creationId xmlns:a16="http://schemas.microsoft.com/office/drawing/2014/main" id="{90B27382-9155-284E-595C-07FA8756C79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55421" y="3598562"/>
              <a:ext cx="4718304" cy="3560064"/>
            </a:xfrm>
            <a:prstGeom prst="rect">
              <a:avLst/>
            </a:prstGeom>
          </p:spPr>
        </p:pic>
        <p:pic>
          <p:nvPicPr>
            <p:cNvPr id="233" name="图片 232" descr="背景图案, 地图&#10;&#10;描述已自动生成">
              <a:extLst>
                <a:ext uri="{FF2B5EF4-FFF2-40B4-BE49-F238E27FC236}">
                  <a16:creationId xmlns:a16="http://schemas.microsoft.com/office/drawing/2014/main" id="{2180AA15-5A16-601F-A72A-394A8FD73B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55421" y="7426544"/>
              <a:ext cx="4718304" cy="3560064"/>
            </a:xfrm>
            <a:prstGeom prst="rect">
              <a:avLst/>
            </a:prstGeom>
          </p:spPr>
        </p:pic>
        <p:pic>
          <p:nvPicPr>
            <p:cNvPr id="234" name="图片 233" descr="图片包含 背景图案&#10;&#10;描述已自动生成">
              <a:extLst>
                <a:ext uri="{FF2B5EF4-FFF2-40B4-BE49-F238E27FC236}">
                  <a16:creationId xmlns:a16="http://schemas.microsoft.com/office/drawing/2014/main" id="{F4F0ACA1-020E-BF45-C738-3AED74B593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53705" y="-5196699"/>
              <a:ext cx="4718304" cy="3560064"/>
            </a:xfrm>
            <a:prstGeom prst="rect">
              <a:avLst/>
            </a:prstGeom>
          </p:spPr>
        </p:pic>
        <p:pic>
          <p:nvPicPr>
            <p:cNvPr id="235" name="图片 234" descr="背景图案&#10;&#10;描述已自动生成">
              <a:extLst>
                <a:ext uri="{FF2B5EF4-FFF2-40B4-BE49-F238E27FC236}">
                  <a16:creationId xmlns:a16="http://schemas.microsoft.com/office/drawing/2014/main" id="{BAC8B7E1-E208-72AC-A7DE-625F010890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62344" y="-1259809"/>
              <a:ext cx="4718304" cy="3560064"/>
            </a:xfrm>
            <a:prstGeom prst="rect">
              <a:avLst/>
            </a:prstGeom>
          </p:spPr>
        </p:pic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9CFC52D4-20FF-837A-9330-4CCAEA723FF9}"/>
                </a:ext>
              </a:extLst>
            </p:cNvPr>
            <p:cNvSpPr txBox="1"/>
            <p:nvPr/>
          </p:nvSpPr>
          <p:spPr>
            <a:xfrm>
              <a:off x="11317226" y="-5904585"/>
              <a:ext cx="415419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CITE2-ACE-spec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B7920CD5-45C3-CFCF-98DA-481E1A43D124}"/>
                </a:ext>
              </a:extLst>
            </p:cNvPr>
            <p:cNvSpPr txBox="1"/>
            <p:nvPr/>
          </p:nvSpPr>
          <p:spPr>
            <a:xfrm>
              <a:off x="-1169948" y="2407871"/>
              <a:ext cx="6074942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VP-RNA-ACE-spec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21B0C496-A182-E093-C088-D2C217745769}"/>
                </a:ext>
              </a:extLst>
            </p:cNvPr>
            <p:cNvSpPr txBox="1"/>
            <p:nvPr/>
          </p:nvSpPr>
          <p:spPr>
            <a:xfrm>
              <a:off x="12782610" y="2927721"/>
              <a:ext cx="520059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CYTOF-ACE-spec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C3F327CE-B8F2-0E52-F746-EE4D8109AACB}"/>
                </a:ext>
              </a:extLst>
            </p:cNvPr>
            <p:cNvSpPr txBox="1"/>
            <p:nvPr/>
          </p:nvSpPr>
          <p:spPr>
            <a:xfrm>
              <a:off x="-8397685" y="-6269347"/>
              <a:ext cx="1884083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6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6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F268681C-F6C3-F4CC-A42E-0CFFE0124B22}"/>
                </a:ext>
              </a:extLst>
            </p:cNvPr>
            <p:cNvSpPr txBox="1"/>
            <p:nvPr/>
          </p:nvSpPr>
          <p:spPr>
            <a:xfrm>
              <a:off x="-8397685" y="2357239"/>
              <a:ext cx="1884083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6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6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47A3ED3E-C2B0-B94A-51EF-628DD6D2AA7B}"/>
                </a:ext>
              </a:extLst>
            </p:cNvPr>
            <p:cNvSpPr txBox="1"/>
            <p:nvPr/>
          </p:nvSpPr>
          <p:spPr>
            <a:xfrm>
              <a:off x="5847035" y="2357239"/>
              <a:ext cx="1884083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6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6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3148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1</Words>
  <Application>Microsoft Office PowerPoint</Application>
  <PresentationFormat>自定义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42:01Z</dcterms:created>
  <dcterms:modified xsi:type="dcterms:W3CDTF">2025-07-20T08:02:12Z</dcterms:modified>
</cp:coreProperties>
</file>